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0" y="73223"/>
            <a:ext cx="81654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ry Figure 3: </a:t>
            </a:r>
            <a:r>
              <a:rPr lang="en-GB" sz="1200" b="1" dirty="0"/>
              <a:t>Kaplan-Meier estimates of DFS (A) and OS (B) according to EVI1 expression in the non-</a:t>
            </a:r>
            <a:r>
              <a:rPr lang="en-GB" sz="1200" b="1" dirty="0" err="1"/>
              <a:t>pCR</a:t>
            </a:r>
            <a:r>
              <a:rPr lang="en-GB" sz="1200" b="1" dirty="0"/>
              <a:t> subgroup</a:t>
            </a:r>
            <a:endParaRPr lang="en-US" sz="1200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457200" y="811670"/>
            <a:ext cx="66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) DFS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876800" y="811670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) OS</a:t>
            </a:r>
          </a:p>
        </p:txBody>
      </p: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A2A24F21-0D14-65BF-B0AC-33F794CECE66}"/>
              </a:ext>
            </a:extLst>
          </p:cNvPr>
          <p:cNvGrpSpPr/>
          <p:nvPr/>
        </p:nvGrpSpPr>
        <p:grpSpPr>
          <a:xfrm>
            <a:off x="152400" y="1114094"/>
            <a:ext cx="3960000" cy="2771297"/>
            <a:chOff x="152400" y="1114094"/>
            <a:chExt cx="3960000" cy="2771297"/>
          </a:xfrm>
        </p:grpSpPr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0949A3B9-90C6-E720-29DB-DB48ECA0F20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2400" y="1114094"/>
              <a:ext cx="3960000" cy="2771297"/>
            </a:xfrm>
            <a:prstGeom prst="rect">
              <a:avLst/>
            </a:prstGeom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2761809D-F311-42F9-2553-FC1461AAEEAF}"/>
                </a:ext>
              </a:extLst>
            </p:cNvPr>
            <p:cNvSpPr txBox="1"/>
            <p:nvPr/>
          </p:nvSpPr>
          <p:spPr>
            <a:xfrm>
              <a:off x="438150" y="3326884"/>
              <a:ext cx="6896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 at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sk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uppieren 14">
            <a:extLst>
              <a:ext uri="{FF2B5EF4-FFF2-40B4-BE49-F238E27FC236}">
                <a16:creationId xmlns:a16="http://schemas.microsoft.com/office/drawing/2014/main" id="{E7B028CF-D875-F657-6D12-D6B9B97B273A}"/>
              </a:ext>
            </a:extLst>
          </p:cNvPr>
          <p:cNvGrpSpPr/>
          <p:nvPr/>
        </p:nvGrpSpPr>
        <p:grpSpPr>
          <a:xfrm>
            <a:off x="4267200" y="1136234"/>
            <a:ext cx="3960000" cy="2756962"/>
            <a:chOff x="4267200" y="1136234"/>
            <a:chExt cx="3960000" cy="2756962"/>
          </a:xfrm>
        </p:grpSpPr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AEA46C5B-B376-0A0D-6EA5-48EB92C8B0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67200" y="1136234"/>
              <a:ext cx="3960000" cy="2756962"/>
            </a:xfrm>
            <a:prstGeom prst="rect">
              <a:avLst/>
            </a:prstGeom>
          </p:spPr>
        </p:pic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3D811C9E-1203-4E6F-C76F-CAE835A89664}"/>
                </a:ext>
              </a:extLst>
            </p:cNvPr>
            <p:cNvSpPr txBox="1"/>
            <p:nvPr/>
          </p:nvSpPr>
          <p:spPr>
            <a:xfrm>
              <a:off x="4513249" y="3333234"/>
              <a:ext cx="6896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 at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sk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92981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ladimirova, Valentina</dc:creator>
  <cp:lastModifiedBy>Vladimirova, Valentina</cp:lastModifiedBy>
  <cp:revision>56</cp:revision>
  <dcterms:created xsi:type="dcterms:W3CDTF">2006-08-16T00:00:00Z</dcterms:created>
  <dcterms:modified xsi:type="dcterms:W3CDTF">2022-07-29T11:25:10Z</dcterms:modified>
</cp:coreProperties>
</file>